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87" r:id="rId2"/>
    <p:sldId id="282" r:id="rId3"/>
    <p:sldId id="284" r:id="rId4"/>
    <p:sldId id="286" r:id="rId5"/>
    <p:sldId id="285" r:id="rId6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160" userDrawn="1">
          <p15:clr>
            <a:srgbClr val="A4A3A4"/>
          </p15:clr>
        </p15:guide>
        <p15:guide id="3" orient="horz" pos="1066" userDrawn="1">
          <p15:clr>
            <a:srgbClr val="A4A3A4"/>
          </p15:clr>
        </p15:guide>
        <p15:guide id="4" orient="horz" pos="2835" userDrawn="1">
          <p15:clr>
            <a:srgbClr val="A4A3A4"/>
          </p15:clr>
        </p15:guide>
        <p15:guide id="6" orient="horz" pos="1451" userDrawn="1">
          <p15:clr>
            <a:srgbClr val="A4A3A4"/>
          </p15:clr>
        </p15:guide>
        <p15:guide id="7" pos="2163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1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821"/>
    <p:restoredTop sz="99839" autoAdjust="0"/>
  </p:normalViewPr>
  <p:slideViewPr>
    <p:cSldViewPr snapToGrid="0" snapToObjects="1" showGuides="1">
      <p:cViewPr>
        <p:scale>
          <a:sx n="178" d="100"/>
          <a:sy n="178" d="100"/>
        </p:scale>
        <p:origin x="144" y="144"/>
      </p:cViewPr>
      <p:guideLst>
        <p:guide pos="2160"/>
        <p:guide orient="horz" pos="1066"/>
        <p:guide orient="horz" pos="2835"/>
        <p:guide orient="horz" pos="1451"/>
        <p:guide pos="216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1BEF3C-F1C3-834E-A6DF-7A89762306FA}" type="datetimeFigureOut">
              <a:rPr lang="en-US" smtClean="0"/>
              <a:t>4/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C2847E-2C90-2842-B810-C83ACCA02D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927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42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255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6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6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028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44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279656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119289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33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98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8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686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223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301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746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316571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8251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AEDD2-3A50-EB4A-8605-FBCB834AECB0}" type="datetimeFigureOut">
              <a:rPr lang="en-US" smtClean="0"/>
              <a:t>4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EF98B7-BF66-674E-8FD3-F9BA50331A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488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F45B1-EA64-468E-97A7-A882247E4E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2150854"/>
          </a:xfrm>
        </p:spPr>
        <p:txBody>
          <a:bodyPr>
            <a:normAutofit fontScale="90000"/>
          </a:bodyPr>
          <a:lstStyle/>
          <a:p>
            <a:r>
              <a:rPr lang="en-US" b="1" dirty="0"/>
              <a:t>Long use of continuous positive airway pressure protects against the development of treatment-requiring retinopathy of prematurity 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62DFCF-0B72-42BD-A2ED-F311E36ACB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uthors:</a:t>
            </a:r>
          </a:p>
          <a:p>
            <a:pPr marL="0" indent="0">
              <a:buNone/>
            </a:pPr>
            <a:r>
              <a:rPr lang="en-US" dirty="0" err="1"/>
              <a:t>Shutaro</a:t>
            </a:r>
            <a:r>
              <a:rPr lang="en-US" dirty="0"/>
              <a:t> Suga, Yuki </a:t>
            </a:r>
            <a:r>
              <a:rPr lang="en-US" dirty="0" err="1"/>
              <a:t>Kyono</a:t>
            </a:r>
            <a:r>
              <a:rPr lang="en-US" dirty="0"/>
              <a:t>, Takumi Kido, </a:t>
            </a:r>
            <a:r>
              <a:rPr lang="en-US" dirty="0" err="1"/>
              <a:t>Ruka</a:t>
            </a:r>
            <a:r>
              <a:rPr lang="en-US" dirty="0"/>
              <a:t> Nakasone, Shinya Abe, Mariko </a:t>
            </a:r>
            <a:r>
              <a:rPr lang="en-US" dirty="0" err="1"/>
              <a:t>Ashina</a:t>
            </a:r>
            <a:r>
              <a:rPr lang="en-US" dirty="0"/>
              <a:t>, </a:t>
            </a:r>
            <a:r>
              <a:rPr lang="en-US" dirty="0" err="1"/>
              <a:t>Kandai</a:t>
            </a:r>
            <a:r>
              <a:rPr lang="en-US" dirty="0"/>
              <a:t> </a:t>
            </a:r>
            <a:r>
              <a:rPr lang="en-US" dirty="0" err="1"/>
              <a:t>Nozu</a:t>
            </a:r>
            <a:r>
              <a:rPr lang="en-US" dirty="0"/>
              <a:t>, </a:t>
            </a:r>
            <a:r>
              <a:rPr lang="en-US" dirty="0" err="1"/>
              <a:t>Kazumichi</a:t>
            </a:r>
            <a:r>
              <a:rPr lang="en-US" dirty="0"/>
              <a:t> Fujioka</a:t>
            </a:r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On behalf of the Neonatal Research Network of Japan</a:t>
            </a:r>
          </a:p>
          <a:p>
            <a:endParaRPr 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10508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5"/>
          <p:cNvSpPr txBox="1"/>
          <p:nvPr/>
        </p:nvSpPr>
        <p:spPr>
          <a:xfrm>
            <a:off x="60559" y="149903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</a:t>
            </a:r>
            <a:r>
              <a:rPr lang="en-US" sz="1200" b="1" dirty="0" err="1">
                <a:latin typeface="Arial"/>
                <a:cs typeface="Arial"/>
              </a:rPr>
              <a:t>S1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" name="TextBox 32">
            <a:extLst>
              <a:ext uri="{FF2B5EF4-FFF2-40B4-BE49-F238E27FC236}">
                <a16:creationId xmlns:a16="http://schemas.microsoft.com/office/drawing/2014/main" id="{FE319EE0-24BF-9246-9E16-929BF3B5E728}"/>
              </a:ext>
            </a:extLst>
          </p:cNvPr>
          <p:cNvSpPr txBox="1"/>
          <p:nvPr/>
        </p:nvSpPr>
        <p:spPr>
          <a:xfrm>
            <a:off x="283406" y="8322057"/>
            <a:ext cx="63007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atient enrolment. NRNJ,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onatal Research Network of Japan; BW, birthweight; ROP, retinopathy of prematurity; TR-ROP, treatment requiring ROP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2F19E60-EFCE-2F47-9E0C-17DA68320E71}"/>
              </a:ext>
            </a:extLst>
          </p:cNvPr>
          <p:cNvSpPr/>
          <p:nvPr/>
        </p:nvSpPr>
        <p:spPr>
          <a:xfrm>
            <a:off x="399579" y="773486"/>
            <a:ext cx="6068367" cy="91878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NRNJ 2009-2018 database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Infants with BW ≤ 1500g, gestational age &lt; 28 weeks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(n = </a:t>
            </a:r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,160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)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530E98C4-FEE7-BE47-9094-8F3A493D909D}"/>
              </a:ext>
            </a:extLst>
          </p:cNvPr>
          <p:cNvCxnSpPr>
            <a:cxnSpLocks/>
          </p:cNvCxnSpPr>
          <p:nvPr/>
        </p:nvCxnSpPr>
        <p:spPr>
          <a:xfrm>
            <a:off x="1024971" y="1692275"/>
            <a:ext cx="0" cy="1750172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>
            <a:extLst>
              <a:ext uri="{FF2B5EF4-FFF2-40B4-BE49-F238E27FC236}">
                <a16:creationId xmlns:a16="http://schemas.microsoft.com/office/drawing/2014/main" id="{59214519-8217-4F45-B769-1043163F2B2A}"/>
              </a:ext>
            </a:extLst>
          </p:cNvPr>
          <p:cNvCxnSpPr>
            <a:cxnSpLocks/>
          </p:cNvCxnSpPr>
          <p:nvPr/>
        </p:nvCxnSpPr>
        <p:spPr>
          <a:xfrm flipV="1">
            <a:off x="1024971" y="2549152"/>
            <a:ext cx="907683" cy="3174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28">
            <a:extLst>
              <a:ext uri="{FF2B5EF4-FFF2-40B4-BE49-F238E27FC236}">
                <a16:creationId xmlns:a16="http://schemas.microsoft.com/office/drawing/2014/main" id="{FAAE13F1-A435-A846-BAC3-1062E6F861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2654" y="1967196"/>
            <a:ext cx="4535292" cy="12003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kumimoji="1" sz="2800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 sz="2000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umimoji="1">
                <a:solidFill>
                  <a:schemeClr val="tx1"/>
                </a:solidFill>
                <a:latin typeface="Yu Gothic" panose="020B0400000000000000" pitchFamily="34" charset="-128"/>
                <a:ea typeface="Yu Gothic" panose="020B0400000000000000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Died before discharge (n =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2,000)</a:t>
            </a:r>
          </a:p>
          <a:p>
            <a:pPr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Major congenital anomalies (n =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736)</a:t>
            </a:r>
            <a:endParaRPr lang="ja-JP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Transferred to another hospital (n = 1,419)</a:t>
            </a:r>
          </a:p>
          <a:p>
            <a:pPr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No available records of ROP (n =</a:t>
            </a:r>
            <a:r>
              <a:rPr lang="ja-JP" altLang="en-US" sz="1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800" dirty="0">
                <a:latin typeface="Arial" panose="020B0604020202020204" pitchFamily="34" charset="0"/>
                <a:cs typeface="Arial" panose="020B0604020202020204" pitchFamily="34" charset="0"/>
              </a:rPr>
              <a:t>2,462)</a:t>
            </a: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4E4B4316-D501-C445-893B-57EC034E398E}"/>
              </a:ext>
            </a:extLst>
          </p:cNvPr>
          <p:cNvSpPr/>
          <p:nvPr/>
        </p:nvSpPr>
        <p:spPr>
          <a:xfrm>
            <a:off x="399579" y="3469341"/>
            <a:ext cx="6068367" cy="73585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Eligible infants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(n = </a:t>
            </a:r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,645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)</a:t>
            </a:r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ABE52617-84C1-4E49-9F67-5314C4A0647F}"/>
              </a:ext>
            </a:extLst>
          </p:cNvPr>
          <p:cNvSpPr/>
          <p:nvPr/>
        </p:nvSpPr>
        <p:spPr>
          <a:xfrm>
            <a:off x="394813" y="7352292"/>
            <a:ext cx="2872821" cy="73585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TR-ROP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(n = 4</a:t>
            </a:r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136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)</a:t>
            </a:r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F26E1475-46B9-9149-82C5-71D855448E34}"/>
              </a:ext>
            </a:extLst>
          </p:cNvPr>
          <p:cNvSpPr/>
          <p:nvPr/>
        </p:nvSpPr>
        <p:spPr>
          <a:xfrm>
            <a:off x="3590360" y="7352292"/>
            <a:ext cx="2872821" cy="735854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Non-TR-ROP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(n = </a:t>
            </a:r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,509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)</a:t>
            </a:r>
            <a:endParaRPr kumimoji="1" lang="ja-JP" altLang="en-US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756D9560-2416-9142-A3FD-531C39B2FE4C}"/>
              </a:ext>
            </a:extLst>
          </p:cNvPr>
          <p:cNvCxnSpPr>
            <a:cxnSpLocks/>
          </p:cNvCxnSpPr>
          <p:nvPr/>
        </p:nvCxnSpPr>
        <p:spPr>
          <a:xfrm>
            <a:off x="1793306" y="6614732"/>
            <a:ext cx="0" cy="647165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5E5C10F0-A618-8647-ACC6-EB38BC770981}"/>
              </a:ext>
            </a:extLst>
          </p:cNvPr>
          <p:cNvCxnSpPr>
            <a:cxnSpLocks/>
          </p:cNvCxnSpPr>
          <p:nvPr/>
        </p:nvCxnSpPr>
        <p:spPr>
          <a:xfrm>
            <a:off x="5026770" y="6614732"/>
            <a:ext cx="0" cy="647165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AA4A63DF-D76C-2040-99B2-486E1730791F}"/>
              </a:ext>
            </a:extLst>
          </p:cNvPr>
          <p:cNvCxnSpPr>
            <a:cxnSpLocks/>
          </p:cNvCxnSpPr>
          <p:nvPr/>
        </p:nvCxnSpPr>
        <p:spPr>
          <a:xfrm>
            <a:off x="1793306" y="6655068"/>
            <a:ext cx="3238230" cy="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A4411CD5-E147-DC40-B983-D441846F89D9}"/>
              </a:ext>
            </a:extLst>
          </p:cNvPr>
          <p:cNvCxnSpPr>
            <a:cxnSpLocks/>
          </p:cNvCxnSpPr>
          <p:nvPr/>
        </p:nvCxnSpPr>
        <p:spPr>
          <a:xfrm flipV="1">
            <a:off x="3431810" y="6130844"/>
            <a:ext cx="0" cy="52254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596D8A2F-690B-2347-A838-C225B59D1095}"/>
              </a:ext>
            </a:extLst>
          </p:cNvPr>
          <p:cNvSpPr/>
          <p:nvPr/>
        </p:nvSpPr>
        <p:spPr>
          <a:xfrm>
            <a:off x="399579" y="4925739"/>
            <a:ext cx="6068367" cy="120342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Infants who did not develop ROP (n =6,604)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+</a:t>
            </a:r>
          </a:p>
          <a:p>
            <a:pPr algn="ctr"/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Infants with a diagnosis of ROP (n = </a:t>
            </a:r>
            <a:r>
              <a:rPr lang="en-US" altLang="ja-JP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,041</a:t>
            </a:r>
            <a:r>
              <a:rPr kumimoji="1" lang="en-US" altLang="ja-JP" dirty="0">
                <a:solidFill>
                  <a:schemeClr val="tx1"/>
                </a:solidFill>
                <a:latin typeface="Arial" panose="020B0604020202020204" pitchFamily="34" charset="0"/>
                <a:ea typeface="Meiryo UI" panose="020B0604030504040204" pitchFamily="34" charset="-128"/>
                <a:cs typeface="Arial" panose="020B0604020202020204" pitchFamily="34" charset="0"/>
              </a:rPr>
              <a:t>)</a:t>
            </a:r>
            <a:endParaRPr kumimoji="1" lang="ja-JP" altLang="en-US" dirty="0">
              <a:solidFill>
                <a:schemeClr val="tx1"/>
              </a:solidFill>
              <a:latin typeface="Arial" panose="020B0604020202020204" pitchFamily="34" charset="0"/>
              <a:ea typeface="Meiryo UI" panose="020B0604030504040204" pitchFamily="34" charset="-128"/>
              <a:cs typeface="Arial" panose="020B0604020202020204" pitchFamily="34" charset="0"/>
            </a:endParaRPr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8F6E6DF1-4F94-6442-B59D-60A842F59C76}"/>
              </a:ext>
            </a:extLst>
          </p:cNvPr>
          <p:cNvCxnSpPr>
            <a:cxnSpLocks/>
          </p:cNvCxnSpPr>
          <p:nvPr/>
        </p:nvCxnSpPr>
        <p:spPr>
          <a:xfrm>
            <a:off x="1024971" y="4205195"/>
            <a:ext cx="0" cy="693376"/>
          </a:xfrm>
          <a:prstGeom prst="straightConnector1">
            <a:avLst/>
          </a:prstGeom>
          <a:ln w="635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48257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5">
            <a:extLst>
              <a:ext uri="{FF2B5EF4-FFF2-40B4-BE49-F238E27FC236}">
                <a16:creationId xmlns:a16="http://schemas.microsoft.com/office/drawing/2014/main" id="{D50228AB-A492-8A49-A420-E27116177B56}"/>
              </a:ext>
            </a:extLst>
          </p:cNvPr>
          <p:cNvSpPr txBox="1"/>
          <p:nvPr/>
        </p:nvSpPr>
        <p:spPr>
          <a:xfrm>
            <a:off x="60559" y="149903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</a:t>
            </a:r>
            <a:r>
              <a:rPr lang="en-US" sz="1200" b="1" dirty="0" err="1">
                <a:latin typeface="Arial"/>
                <a:cs typeface="Arial"/>
              </a:rPr>
              <a:t>S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" name="TextBox 32">
            <a:extLst>
              <a:ext uri="{FF2B5EF4-FFF2-40B4-BE49-F238E27FC236}">
                <a16:creationId xmlns:a16="http://schemas.microsoft.com/office/drawing/2014/main" id="{062C450E-E03C-7347-A88B-953070A9D027}"/>
              </a:ext>
            </a:extLst>
          </p:cNvPr>
          <p:cNvSpPr txBox="1"/>
          <p:nvPr/>
        </p:nvSpPr>
        <p:spPr>
          <a:xfrm>
            <a:off x="284411" y="6327615"/>
            <a:ext cx="630071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ends in the proportion of patients with TR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hite and gray bars represent Non-TR-ROP and TR-ROP, respectively. T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proportion of patients with TR-ROP did not change significantly throughout the study period (p=0.02, Chi-square test for trend). The data were not adjusted for gestational age. </a:t>
            </a:r>
          </a:p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tinopathy of prematurity; TR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reatment requiring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E61C782A-821A-524F-B484-B7500BC933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124" y="667657"/>
            <a:ext cx="6300000" cy="4291304"/>
          </a:xfrm>
          <a:prstGeom prst="rect">
            <a:avLst/>
          </a:prstGeom>
        </p:spPr>
      </p:pic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1CBD19D-C816-9E42-B12D-22AA02676A1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2725425"/>
              </p:ext>
            </p:extLst>
          </p:nvPr>
        </p:nvGraphicFramePr>
        <p:xfrm>
          <a:off x="471486" y="5199716"/>
          <a:ext cx="5915027" cy="62716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23767">
                  <a:extLst>
                    <a:ext uri="{9D8B030D-6E8A-4147-A177-3AD203B41FA5}">
                      <a16:colId xmlns:a16="http://schemas.microsoft.com/office/drawing/2014/main" val="3518947987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127855993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3266539147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3273695334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2799107543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4134986190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2078583704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1501745718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3657372459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697257764"/>
                    </a:ext>
                  </a:extLst>
                </a:gridCol>
                <a:gridCol w="439126">
                  <a:extLst>
                    <a:ext uri="{9D8B030D-6E8A-4147-A177-3AD203B41FA5}">
                      <a16:colId xmlns:a16="http://schemas.microsoft.com/office/drawing/2014/main" val="2619590509"/>
                    </a:ext>
                  </a:extLst>
                </a:gridCol>
              </a:tblGrid>
              <a:tr h="144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Year 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09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0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1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2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3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4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5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6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7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018</a:t>
                      </a:r>
                      <a:endParaRPr lang="en-US" altLang="ja-JP" sz="11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5711002"/>
                  </a:ext>
                </a:extLst>
              </a:tr>
              <a:tr h="117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TR-ROP (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432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47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47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55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443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8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42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8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0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5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8145563"/>
                  </a:ext>
                </a:extLst>
              </a:tr>
              <a:tr h="117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NON-TR-ROP (n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100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1081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1064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106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100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955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1007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878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740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u="none" strike="noStrike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709</a:t>
                      </a:r>
                      <a:endParaRPr lang="en-US" altLang="ja-JP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9425139"/>
                  </a:ext>
                </a:extLst>
              </a:tr>
              <a:tr h="117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Proportion (%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0.1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0.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1.0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4.3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0.5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8.7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9.9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30.4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8.9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u="none" strike="noStrike" dirty="0">
                          <a:effectLst/>
                          <a:latin typeface="Times New Roman" panose="02020603050405020304" pitchFamily="18" charset="0"/>
                          <a:ea typeface="Meiryo UI" panose="020B0604030504040204" pitchFamily="34" charset="-128"/>
                          <a:cs typeface="Times New Roman" panose="02020603050405020304" pitchFamily="18" charset="0"/>
                        </a:rPr>
                        <a:t>26.8</a:t>
                      </a:r>
                      <a:endParaRPr lang="en-US" altLang="ja-JP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Meiryo UI" panose="020B060403050404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59018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453175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5">
            <a:extLst>
              <a:ext uri="{FF2B5EF4-FFF2-40B4-BE49-F238E27FC236}">
                <a16:creationId xmlns:a16="http://schemas.microsoft.com/office/drawing/2014/main" id="{D50228AB-A492-8A49-A420-E27116177B56}"/>
              </a:ext>
            </a:extLst>
          </p:cNvPr>
          <p:cNvSpPr txBox="1"/>
          <p:nvPr/>
        </p:nvSpPr>
        <p:spPr>
          <a:xfrm>
            <a:off x="60559" y="149903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</a:t>
            </a:r>
            <a:r>
              <a:rPr lang="en-US" sz="1200" b="1" dirty="0" err="1">
                <a:latin typeface="Arial"/>
                <a:cs typeface="Arial"/>
              </a:rPr>
              <a:t>S3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" name="TextBox 32">
            <a:extLst>
              <a:ext uri="{FF2B5EF4-FFF2-40B4-BE49-F238E27FC236}">
                <a16:creationId xmlns:a16="http://schemas.microsoft.com/office/drawing/2014/main" id="{062C450E-E03C-7347-A88B-953070A9D027}"/>
              </a:ext>
            </a:extLst>
          </p:cNvPr>
          <p:cNvSpPr txBox="1"/>
          <p:nvPr/>
        </p:nvSpPr>
        <p:spPr>
          <a:xfrm>
            <a:off x="284411" y="6327615"/>
            <a:ext cx="630071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ends in the gestational age of infants screened for ROP over the study perio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data are expressed as mea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 S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mean gestational age of enrolled infants showed slight but significant decreasing tre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oughout the study period (p&lt;0.01, One-way ANOVA test).</a:t>
            </a:r>
          </a:p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tinopathy of prematurity; SD, standard deviation</a:t>
            </a:r>
          </a:p>
        </p:txBody>
      </p:sp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99CD2ED-A346-9348-8B4B-7CA6FEDA00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4842270"/>
              </p:ext>
            </p:extLst>
          </p:nvPr>
        </p:nvGraphicFramePr>
        <p:xfrm>
          <a:off x="276880" y="5199715"/>
          <a:ext cx="6325956" cy="5867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29626">
                  <a:extLst>
                    <a:ext uri="{9D8B030D-6E8A-4147-A177-3AD203B41FA5}">
                      <a16:colId xmlns:a16="http://schemas.microsoft.com/office/drawing/2014/main" val="3518947987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127855993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3266539147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3273695334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2799107543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4134986190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2078583704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1501745718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3657372459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697257764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2619590509"/>
                    </a:ext>
                  </a:extLst>
                </a:gridCol>
              </a:tblGrid>
              <a:tr h="907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Year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5711002"/>
                  </a:ext>
                </a:extLst>
              </a:tr>
              <a:tr h="907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Mean  (weeks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3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4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3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3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2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.2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8145563"/>
                  </a:ext>
                </a:extLst>
              </a:tr>
              <a:tr h="907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S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3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.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9425139"/>
                  </a:ext>
                </a:extLst>
              </a:tr>
              <a:tr h="9072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Number of infants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5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4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3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6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4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900" b="0" i="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4970648"/>
                  </a:ext>
                </a:extLst>
              </a:tr>
            </a:tbl>
          </a:graphicData>
        </a:graphic>
      </p:graphicFrame>
      <p:pic>
        <p:nvPicPr>
          <p:cNvPr id="3" name="図 2">
            <a:extLst>
              <a:ext uri="{FF2B5EF4-FFF2-40B4-BE49-F238E27FC236}">
                <a16:creationId xmlns:a16="http://schemas.microsoft.com/office/drawing/2014/main" id="{EDDB33DC-070D-2945-820F-65E2A854BF3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880" y="426902"/>
            <a:ext cx="6300000" cy="45102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44331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5">
            <a:extLst>
              <a:ext uri="{FF2B5EF4-FFF2-40B4-BE49-F238E27FC236}">
                <a16:creationId xmlns:a16="http://schemas.microsoft.com/office/drawing/2014/main" id="{D50228AB-A492-8A49-A420-E27116177B56}"/>
              </a:ext>
            </a:extLst>
          </p:cNvPr>
          <p:cNvSpPr txBox="1"/>
          <p:nvPr/>
        </p:nvSpPr>
        <p:spPr>
          <a:xfrm>
            <a:off x="60559" y="149903"/>
            <a:ext cx="20409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Supplementary Figure </a:t>
            </a:r>
            <a:r>
              <a:rPr lang="en-US" sz="1200" b="1" dirty="0" err="1">
                <a:latin typeface="Arial"/>
                <a:cs typeface="Arial"/>
              </a:rPr>
              <a:t>S4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10" name="TextBox 32">
            <a:extLst>
              <a:ext uri="{FF2B5EF4-FFF2-40B4-BE49-F238E27FC236}">
                <a16:creationId xmlns:a16="http://schemas.microsoft.com/office/drawing/2014/main" id="{062C450E-E03C-7347-A88B-953070A9D027}"/>
              </a:ext>
            </a:extLst>
          </p:cNvPr>
          <p:cNvSpPr txBox="1"/>
          <p:nvPr/>
        </p:nvSpPr>
        <p:spPr>
          <a:xfrm>
            <a:off x="284411" y="6327615"/>
            <a:ext cx="630071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rends in the proportion of patients receiving anti-VEGF treatment for TR-RO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hite and gray bars represent other and anti-VEGF treatment, respectively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roportion of patients receiving anti-VEGF treatment for TR-ROP showed a significant increasing trend throughout the study period (p&lt;0.0001, Chi-square test for trend).</a:t>
            </a:r>
          </a:p>
          <a:p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tinopathy of prematurity; TR-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reatment requiring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VEGF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soendothelial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wth factor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A758C35A-CFFD-B34C-AD54-C30A8356C8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5850" y="611822"/>
            <a:ext cx="6300000" cy="4402974"/>
          </a:xfrm>
          <a:prstGeom prst="rect">
            <a:avLst/>
          </a:prstGeom>
        </p:spPr>
      </p:pic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99CD2ED-A346-9348-8B4B-7CA6FEDA00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3806068"/>
              </p:ext>
            </p:extLst>
          </p:nvPr>
        </p:nvGraphicFramePr>
        <p:xfrm>
          <a:off x="276880" y="5199716"/>
          <a:ext cx="6325956" cy="5867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29626">
                  <a:extLst>
                    <a:ext uri="{9D8B030D-6E8A-4147-A177-3AD203B41FA5}">
                      <a16:colId xmlns:a16="http://schemas.microsoft.com/office/drawing/2014/main" val="3518947987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127855993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3266539147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3273695334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2799107543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4134986190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2078583704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1501745718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3657372459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697257764"/>
                    </a:ext>
                  </a:extLst>
                </a:gridCol>
                <a:gridCol w="469633">
                  <a:extLst>
                    <a:ext uri="{9D8B030D-6E8A-4147-A177-3AD203B41FA5}">
                      <a16:colId xmlns:a16="http://schemas.microsoft.com/office/drawing/2014/main" val="2619590509"/>
                    </a:ext>
                  </a:extLst>
                </a:gridCol>
              </a:tblGrid>
              <a:tr h="144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Year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0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01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5711002"/>
                  </a:ext>
                </a:extLst>
              </a:tr>
              <a:tr h="117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Anti-VEGF antibody treatment (n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6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38145563"/>
                  </a:ext>
                </a:extLst>
              </a:tr>
              <a:tr h="117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Other treatment (n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3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7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7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4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8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0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5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39425139"/>
                  </a:ext>
                </a:extLst>
              </a:tr>
              <a:tr h="117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Proportion (%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5.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7.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9.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3.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4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5.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34" charset="-128"/>
                          <a:cs typeface="Times New Roman" panose="02020603050405020304" pitchFamily="18" charset="0"/>
                        </a:rPr>
                        <a:t>19.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59018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23753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68</TotalTime>
  <Words>552</Words>
  <Application>Microsoft Macintosh PowerPoint</Application>
  <PresentationFormat>レター サイズ 8.5x11 インチ</PresentationFormat>
  <Paragraphs>164</Paragraphs>
  <Slides>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4" baseType="lpstr">
      <vt:lpstr>Meiryo UI</vt:lpstr>
      <vt:lpstr>ＭＳ Ｐゴシック</vt:lpstr>
      <vt:lpstr>Yu Gothic</vt:lpstr>
      <vt:lpstr>Yu Gothic</vt:lpstr>
      <vt:lpstr>Arial</vt:lpstr>
      <vt:lpstr>Calibri</vt:lpstr>
      <vt:lpstr>Calibri Light</vt:lpstr>
      <vt:lpstr>Times New Roman</vt:lpstr>
      <vt:lpstr>Office Theme</vt:lpstr>
      <vt:lpstr>Long use of continuous positive airway pressure protects against the development of treatment-requiring retinopathy of prematurity  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 Wong</dc:creator>
  <cp:lastModifiedBy>Microsoft Office User</cp:lastModifiedBy>
  <cp:revision>178</cp:revision>
  <cp:lastPrinted>2017-11-17T17:44:09Z</cp:lastPrinted>
  <dcterms:created xsi:type="dcterms:W3CDTF">2015-12-18T03:10:19Z</dcterms:created>
  <dcterms:modified xsi:type="dcterms:W3CDTF">2022-04-04T09:38:36Z</dcterms:modified>
</cp:coreProperties>
</file>